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1B8617-7EDC-7BED-02CA-03137B7EDD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9EC9866-E42C-E590-B899-EB6BF579FC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5E25C68-C74F-F5D0-BB4C-122222421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C88091A-9FA8-E190-06C8-7DE959AF0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81F6C0F-19EE-C8F3-F176-BE4F4247B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384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52B00E-56FA-DC11-34AF-5FA67BD24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2D4D065-12D1-C11D-0FF4-00BFD21BC9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980184-0161-D4E3-BBD4-D5000B703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568A0A-AF4D-C78F-9274-973BAE341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EC2B6A7-18DE-C585-77FF-62CE89244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6642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3F4B3D3-14BE-FBE2-C3D9-AAB3FC7119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A17EEA3-2519-C63A-21F5-EC5B5B707F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B686DFD-F412-C2A5-97D5-86722F2A4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DAED89-DBF3-F8F7-AB9E-F5C9A3F80A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A5850E5-A783-8F22-6347-82072B60E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4272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C333177-FF97-EAE9-9406-0070D8AD7C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D6FA43E-322D-1F0B-EB40-AD3A72FA81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FC8A23C-9DA0-F9B5-269B-21B050DE2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EA32EE-E08E-23AF-F7A8-F5DBBD0CB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AA4BD2-C8B0-762F-D8B5-7D5A87E94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8033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675D59C-8206-F952-EBF4-592F75D2DD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70251FA-8E4E-E2EF-9874-AAB67AD32D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15A8BEB-734A-4A16-BBAA-1C7648E8B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4A64189-7823-1FA6-B050-E7042B672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CC7CE4-44A6-06D6-5E0E-CBC5A69DC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7251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C3F6FA-5023-AE5F-4E33-847C20F87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FEAE5E8-A0A9-CF60-D213-B3B1951F47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97AB6EF-ECAE-1715-39DC-DA24A4E280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2BF478C-2CC5-B6C7-B905-CE36E183F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BCFBB20-B1E7-DF75-C840-30D12A911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DB201B0-CD96-DFC6-FDD2-877DCBAE0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7149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7AA39A2-9DCF-B623-4AE7-9EAAE44C8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47CA069-331A-CC7C-3E61-87EEB46794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9A2E631-3545-AB89-A9CB-AFFC7182E4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2A43B5D-29F6-41AD-91A0-7DB4D17728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28439A6-6C39-619F-CE9A-C381D0E21C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AA1D419-AC3C-F9A2-84AB-57283D20A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E5B2FB2-B94B-5B38-A243-50BA898C0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49D236C-956A-BE69-68F5-4D9F59F5B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1505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0C6584-B254-7585-4F24-E3491BD432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99AA134-BF86-8AF0-C556-99DF27AF2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74D1D1E-909D-4611-57F6-502763172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563100A-8E83-F5A5-4B88-7BE61872C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1609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EB819CA-CC7D-C0A5-8027-1F2C5B0FB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B448CFC-2A12-E62C-14E0-AA2D50FE7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96242AD-DA00-9118-0296-0AEB794C3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9995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5EE9DB-3DB7-C854-BF5A-1CA6AB526E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646E32D-7EC3-424B-5701-0660041C5D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A7A36A6-FDAB-792B-A471-90891305EC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267FC33-D5B6-7148-87B5-4854DBF0F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1ABB735-F30C-BB7C-EAF7-DF20E8223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8852B51-D87E-A7CC-15B2-EEDE55F83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5345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52E2883-783A-888A-2C08-F29A3F94E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3762BD8-BA86-6A00-B4BB-CA68F6BEE5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7614426-E168-51CE-E999-9274847CC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4DDCC5E-A1B2-C90E-5607-80C76D0B9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9E8CF4B-6641-A789-8DC3-49FBFAD8D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1E1E3D3-4B3F-E672-A8CD-A4277B6B2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4360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668D5D3-D955-1D7F-0FFD-977745DF3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C53EE09-30D4-5A94-3E34-5262D88F36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42E36D1-A8F1-D22F-5F04-AEAEC46B32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9FFE1-6780-48DF-8B53-B0E718712E40}" type="datetimeFigureOut">
              <a:rPr lang="it-IT" smtClean="0"/>
              <a:t>07/11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1975A85-1BE9-D583-6D85-73E1378AE6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6000731-F5D3-2683-023E-9BCF92DC85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A5755-10A6-4F2B-B876-23A873D75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147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E86D3217-1811-A3EA-696D-ED4202BF721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5152" y="511022"/>
            <a:ext cx="6048730" cy="3974505"/>
          </a:xfrm>
          <a:prstGeom prst="rect">
            <a:avLst/>
          </a:prstGeom>
        </p:spPr>
      </p:pic>
      <p:sp>
        <p:nvSpPr>
          <p:cNvPr id="3" name="Casella di testo 2">
            <a:extLst>
              <a:ext uri="{FF2B5EF4-FFF2-40B4-BE49-F238E27FC236}">
                <a16:creationId xmlns:a16="http://schemas.microsoft.com/office/drawing/2014/main" id="{C06772EB-05C2-497C-B5D7-17FB82877F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8187" y="5053206"/>
            <a:ext cx="8550172" cy="83099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/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Here,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t</a:t>
            </a:r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s</a:t>
            </a:r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represented</a:t>
            </a:r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how</a:t>
            </a:r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the PM2.5 can impact on the human body. </a:t>
            </a:r>
          </a:p>
          <a:p>
            <a:pPr algn="just"/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The air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particulate</a:t>
            </a:r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s</a:t>
            </a:r>
            <a:r>
              <a:rPr lang="it-IT" sz="1200" dirty="0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effectLst/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nhaled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reache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the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pulmonary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alveoli and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t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transferred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to the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bloodstream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; in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thi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way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t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enter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the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cell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metabolism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mpairing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t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. In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particular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there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are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consequence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on the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miRNA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regulation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that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in turns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ha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effects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on the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inflammation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state,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cell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proliferation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and </a:t>
            </a:r>
            <a:r>
              <a:rPr lang="it-IT" sz="1200" dirty="0" err="1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oxidative</a:t>
            </a:r>
            <a:r>
              <a:rPr lang="it-IT" sz="1200" dirty="0">
                <a:highlight>
                  <a:srgbClr val="FFFFFF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 stress.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95602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7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ia lo dico</dc:creator>
  <cp:lastModifiedBy>alessia lo dico</cp:lastModifiedBy>
  <cp:revision>5</cp:revision>
  <dcterms:created xsi:type="dcterms:W3CDTF">2023-10-30T09:29:51Z</dcterms:created>
  <dcterms:modified xsi:type="dcterms:W3CDTF">2023-11-07T09:52:52Z</dcterms:modified>
</cp:coreProperties>
</file>